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9" autoAdjust="0"/>
    <p:restoredTop sz="94660"/>
  </p:normalViewPr>
  <p:slideViewPr>
    <p:cSldViewPr snapToGrid="0">
      <p:cViewPr varScale="1">
        <p:scale>
          <a:sx n="65" d="100"/>
          <a:sy n="65" d="100"/>
        </p:scale>
        <p:origin x="145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ka Komori (小森 裕香)" userId="ea66856c-9887-44c3-a5b4-fa7013576a88" providerId="ADAL" clId="{4FEB186A-767F-47ED-8EC5-77D7ED34A658}"/>
    <pc:docChg chg="custSel modSld">
      <pc:chgData name="Yuka Komori (小森 裕香)" userId="ea66856c-9887-44c3-a5b4-fa7013576a88" providerId="ADAL" clId="{4FEB186A-767F-47ED-8EC5-77D7ED34A658}" dt="2023-03-09T10:47:39.863" v="42" actId="1076"/>
      <pc:docMkLst>
        <pc:docMk/>
      </pc:docMkLst>
      <pc:sldChg chg="modSp mod">
        <pc:chgData name="Yuka Komori (小森 裕香)" userId="ea66856c-9887-44c3-a5b4-fa7013576a88" providerId="ADAL" clId="{4FEB186A-767F-47ED-8EC5-77D7ED34A658}" dt="2023-03-09T10:38:23.733" v="32" actId="6549"/>
        <pc:sldMkLst>
          <pc:docMk/>
          <pc:sldMk cId="3913390716" sldId="256"/>
        </pc:sldMkLst>
        <pc:spChg chg="mod">
          <ac:chgData name="Yuka Komori (小森 裕香)" userId="ea66856c-9887-44c3-a5b4-fa7013576a88" providerId="ADAL" clId="{4FEB186A-767F-47ED-8EC5-77D7ED34A658}" dt="2023-03-09T10:38:23.733" v="32" actId="6549"/>
          <ac:spMkLst>
            <pc:docMk/>
            <pc:sldMk cId="3913390716" sldId="256"/>
            <ac:spMk id="3" creationId="{6664D567-9733-C2B0-4A3D-582C37AA3698}"/>
          </ac:spMkLst>
        </pc:spChg>
      </pc:sldChg>
      <pc:sldChg chg="addSp delSp modSp mod">
        <pc:chgData name="Yuka Komori (小森 裕香)" userId="ea66856c-9887-44c3-a5b4-fa7013576a88" providerId="ADAL" clId="{4FEB186A-767F-47ED-8EC5-77D7ED34A658}" dt="2023-03-09T10:47:39.863" v="42" actId="1076"/>
        <pc:sldMkLst>
          <pc:docMk/>
          <pc:sldMk cId="2855984682" sldId="258"/>
        </pc:sldMkLst>
        <pc:spChg chg="mod">
          <ac:chgData name="Yuka Komori (小森 裕香)" userId="ea66856c-9887-44c3-a5b4-fa7013576a88" providerId="ADAL" clId="{4FEB186A-767F-47ED-8EC5-77D7ED34A658}" dt="2023-03-09T10:39:07.670" v="33" actId="1076"/>
          <ac:spMkLst>
            <pc:docMk/>
            <pc:sldMk cId="2855984682" sldId="258"/>
            <ac:spMk id="2" creationId="{FDD5C823-45C1-B405-4038-A0B86E21696C}"/>
          </ac:spMkLst>
        </pc:spChg>
        <pc:spChg chg="add del mod">
          <ac:chgData name="Yuka Komori (小森 裕香)" userId="ea66856c-9887-44c3-a5b4-fa7013576a88" providerId="ADAL" clId="{4FEB186A-767F-47ED-8EC5-77D7ED34A658}" dt="2023-03-09T10:46:31.939" v="36" actId="478"/>
          <ac:spMkLst>
            <pc:docMk/>
            <pc:sldMk cId="2855984682" sldId="258"/>
            <ac:spMk id="4" creationId="{3E205E8C-2E55-01CD-E7FA-C83FB6ED1E7F}"/>
          </ac:spMkLst>
        </pc:spChg>
        <pc:spChg chg="add del mod">
          <ac:chgData name="Yuka Komori (小森 裕香)" userId="ea66856c-9887-44c3-a5b4-fa7013576a88" providerId="ADAL" clId="{4FEB186A-767F-47ED-8EC5-77D7ED34A658}" dt="2023-03-09T10:46:31.939" v="36" actId="478"/>
          <ac:spMkLst>
            <pc:docMk/>
            <pc:sldMk cId="2855984682" sldId="258"/>
            <ac:spMk id="5" creationId="{CC2F68ED-0217-C159-A70C-58B8841556E6}"/>
          </ac:spMkLst>
        </pc:spChg>
        <pc:spChg chg="add del mod">
          <ac:chgData name="Yuka Komori (小森 裕香)" userId="ea66856c-9887-44c3-a5b4-fa7013576a88" providerId="ADAL" clId="{4FEB186A-767F-47ED-8EC5-77D7ED34A658}" dt="2023-03-09T10:46:31.939" v="36" actId="478"/>
          <ac:spMkLst>
            <pc:docMk/>
            <pc:sldMk cId="2855984682" sldId="258"/>
            <ac:spMk id="7" creationId="{BF2991D5-A9BD-780C-EC5D-827129E5B270}"/>
          </ac:spMkLst>
        </pc:spChg>
        <pc:spChg chg="add del mod">
          <ac:chgData name="Yuka Komori (小森 裕香)" userId="ea66856c-9887-44c3-a5b4-fa7013576a88" providerId="ADAL" clId="{4FEB186A-767F-47ED-8EC5-77D7ED34A658}" dt="2023-03-09T10:46:31.939" v="36" actId="478"/>
          <ac:spMkLst>
            <pc:docMk/>
            <pc:sldMk cId="2855984682" sldId="258"/>
            <ac:spMk id="8" creationId="{3518E332-347B-F0E3-D29E-46A7FA6A1D93}"/>
          </ac:spMkLst>
        </pc:spChg>
        <pc:spChg chg="add del mod">
          <ac:chgData name="Yuka Komori (小森 裕香)" userId="ea66856c-9887-44c3-a5b4-fa7013576a88" providerId="ADAL" clId="{4FEB186A-767F-47ED-8EC5-77D7ED34A658}" dt="2023-03-09T10:46:31.939" v="36" actId="478"/>
          <ac:spMkLst>
            <pc:docMk/>
            <pc:sldMk cId="2855984682" sldId="258"/>
            <ac:spMk id="9" creationId="{D52E5DFB-CCF8-DE3C-D83A-5428CB9FA926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24" creationId="{D69B3BC3-7F74-5AC1-E2A6-8238AE852281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25" creationId="{365C8AC0-5643-594E-12A1-0885633A1C53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26" creationId="{5B863AE6-E0E1-D460-D894-7F67BB54F65A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27" creationId="{C79CEE9B-EA8F-8FD1-DEF3-BC5E80466A7D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28" creationId="{600E8CD1-7230-2C8A-5596-C260B24A0282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30" creationId="{67954CCD-A8B3-C8BD-40E2-C5C586EB537D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31" creationId="{068BB43C-5C13-DBBF-2D74-AFA6299C3716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32" creationId="{D5EE096B-AE84-42AA-85C0-D50A65544E97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33" creationId="{460D6F23-7BA6-8DF3-E8B2-118A004EBA54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34" creationId="{4626BE15-F4DA-68E2-FD86-5EABD2F0AE75}"/>
          </ac:spMkLst>
        </pc:spChg>
        <pc:spChg chg="mod">
          <ac:chgData name="Yuka Komori (小森 裕香)" userId="ea66856c-9887-44c3-a5b4-fa7013576a88" providerId="ADAL" clId="{4FEB186A-767F-47ED-8EC5-77D7ED34A658}" dt="2023-03-09T10:46:22.981" v="34"/>
          <ac:spMkLst>
            <pc:docMk/>
            <pc:sldMk cId="2855984682" sldId="258"/>
            <ac:spMk id="35" creationId="{7DCC1A83-B2C6-7FC7-36E8-6B870F6E29FB}"/>
          </ac:spMkLst>
        </pc:spChg>
        <pc:grpChg chg="add del mod">
          <ac:chgData name="Yuka Komori (小森 裕香)" userId="ea66856c-9887-44c3-a5b4-fa7013576a88" providerId="ADAL" clId="{4FEB186A-767F-47ED-8EC5-77D7ED34A658}" dt="2023-03-09T10:46:31.939" v="36" actId="478"/>
          <ac:grpSpMkLst>
            <pc:docMk/>
            <pc:sldMk cId="2855984682" sldId="258"/>
            <ac:grpSpMk id="10" creationId="{A2BAD7AA-8C7C-BEE4-A90D-726E3BF03339}"/>
          </ac:grpSpMkLst>
        </pc:grpChg>
        <pc:grpChg chg="add del mod">
          <ac:chgData name="Yuka Komori (小森 裕香)" userId="ea66856c-9887-44c3-a5b4-fa7013576a88" providerId="ADAL" clId="{4FEB186A-767F-47ED-8EC5-77D7ED34A658}" dt="2023-03-09T10:46:31.939" v="36" actId="478"/>
          <ac:grpSpMkLst>
            <pc:docMk/>
            <pc:sldMk cId="2855984682" sldId="258"/>
            <ac:grpSpMk id="16" creationId="{E39A30AD-76C4-7AC0-8191-B071D45AEAE0}"/>
          </ac:grpSpMkLst>
        </pc:grpChg>
        <pc:grpChg chg="add del mod">
          <ac:chgData name="Yuka Komori (小森 裕香)" userId="ea66856c-9887-44c3-a5b4-fa7013576a88" providerId="ADAL" clId="{4FEB186A-767F-47ED-8EC5-77D7ED34A658}" dt="2023-03-09T10:46:31.939" v="36" actId="478"/>
          <ac:grpSpMkLst>
            <pc:docMk/>
            <pc:sldMk cId="2855984682" sldId="258"/>
            <ac:grpSpMk id="23" creationId="{379EB070-FFCF-C7CA-72C5-8A2E3A8B7901}"/>
          </ac:grpSpMkLst>
        </pc:grpChg>
        <pc:grpChg chg="add del mod">
          <ac:chgData name="Yuka Komori (小森 裕香)" userId="ea66856c-9887-44c3-a5b4-fa7013576a88" providerId="ADAL" clId="{4FEB186A-767F-47ED-8EC5-77D7ED34A658}" dt="2023-03-09T10:46:31.939" v="36" actId="478"/>
          <ac:grpSpMkLst>
            <pc:docMk/>
            <pc:sldMk cId="2855984682" sldId="258"/>
            <ac:grpSpMk id="29" creationId="{A4E8886C-C5A4-A50E-E45B-690645A57DD8}"/>
          </ac:grpSpMkLst>
        </pc:grpChg>
        <pc:graphicFrameChg chg="add del mod">
          <ac:chgData name="Yuka Komori (小森 裕香)" userId="ea66856c-9887-44c3-a5b4-fa7013576a88" providerId="ADAL" clId="{4FEB186A-767F-47ED-8EC5-77D7ED34A658}" dt="2023-03-09T10:46:31.939" v="36" actId="478"/>
          <ac:graphicFrameMkLst>
            <pc:docMk/>
            <pc:sldMk cId="2855984682" sldId="258"/>
            <ac:graphicFrameMk id="3" creationId="{F3E34418-0965-B749-E44A-E7A5E8841F4A}"/>
          </ac:graphicFrameMkLst>
        </pc:graphicFrameChg>
        <pc:picChg chg="del">
          <ac:chgData name="Yuka Komori (小森 裕香)" userId="ea66856c-9887-44c3-a5b4-fa7013576a88" providerId="ADAL" clId="{4FEB186A-767F-47ED-8EC5-77D7ED34A658}" dt="2023-03-09T10:47:37.936" v="41" actId="478"/>
          <ac:picMkLst>
            <pc:docMk/>
            <pc:sldMk cId="2855984682" sldId="258"/>
            <ac:picMk id="6" creationId="{EC370228-CD5F-C447-056F-91ABA47697CC}"/>
          </ac:picMkLst>
        </pc:picChg>
        <pc:picChg chg="add mod">
          <ac:chgData name="Yuka Komori (小森 裕香)" userId="ea66856c-9887-44c3-a5b4-fa7013576a88" providerId="ADAL" clId="{4FEB186A-767F-47ED-8EC5-77D7ED34A658}" dt="2023-03-09T10:47:39.863" v="42" actId="1076"/>
          <ac:picMkLst>
            <pc:docMk/>
            <pc:sldMk cId="2855984682" sldId="258"/>
            <ac:picMk id="37" creationId="{BC3DD355-D3BB-0D28-C8E6-C3147741FC30}"/>
          </ac:picMkLst>
        </pc:pic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11" creationId="{F63DE31C-3816-13BA-C4FB-AD0698631413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12" creationId="{15EC50D7-F067-899E-5AC2-A3C4C2BAA2BC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13" creationId="{8135AE97-947C-492F-DB0C-D5567F16D51E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14" creationId="{E7F8503B-12C1-4B59-0A23-ED1A1DB05787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15" creationId="{350DC64B-ED30-13A0-413E-B6C3D5C985D0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17" creationId="{2912A3A5-97F6-6680-1808-F956FA195BA3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18" creationId="{D1FCA72E-2782-08E7-9D35-12A209313EC2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19" creationId="{39B31919-EFFC-55A1-4205-44239D5A5DB1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20" creationId="{F2820A7B-3612-A5FD-80E9-D4325C37D9C4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21" creationId="{07BAC307-4066-172E-2A5C-EF2B820FA192}"/>
          </ac:cxnSpMkLst>
        </pc:cxnChg>
        <pc:cxnChg chg="mod">
          <ac:chgData name="Yuka Komori (小森 裕香)" userId="ea66856c-9887-44c3-a5b4-fa7013576a88" providerId="ADAL" clId="{4FEB186A-767F-47ED-8EC5-77D7ED34A658}" dt="2023-03-09T10:46:22.981" v="34"/>
          <ac:cxnSpMkLst>
            <pc:docMk/>
            <pc:sldMk cId="2855984682" sldId="258"/>
            <ac:cxnSpMk id="22" creationId="{8BB1FBBF-5862-F3F1-C1DC-43D0A0701F1A}"/>
          </ac:cxnSpMkLst>
        </pc:cxnChg>
      </pc:sldChg>
    </pc:docChg>
  </pc:docChgLst>
  <pc:docChgLst>
    <pc:chgData name="Yuka Komori (小森 裕香)" userId="ea66856c-9887-44c3-a5b4-fa7013576a88" providerId="ADAL" clId="{A273B740-BFDD-4EA9-A43F-9869F50C3DDC}"/>
    <pc:docChg chg="modSld">
      <pc:chgData name="Yuka Komori (小森 裕香)" userId="ea66856c-9887-44c3-a5b4-fa7013576a88" providerId="ADAL" clId="{A273B740-BFDD-4EA9-A43F-9869F50C3DDC}" dt="2023-03-06T06:02:25.155" v="4" actId="20577"/>
      <pc:docMkLst>
        <pc:docMk/>
      </pc:docMkLst>
      <pc:sldChg chg="modSp mod">
        <pc:chgData name="Yuka Komori (小森 裕香)" userId="ea66856c-9887-44c3-a5b4-fa7013576a88" providerId="ADAL" clId="{A273B740-BFDD-4EA9-A43F-9869F50C3DDC}" dt="2023-03-06T06:02:25.155" v="4" actId="20577"/>
        <pc:sldMkLst>
          <pc:docMk/>
          <pc:sldMk cId="2312700950" sldId="257"/>
        </pc:sldMkLst>
        <pc:spChg chg="mod">
          <ac:chgData name="Yuka Komori (小森 裕香)" userId="ea66856c-9887-44c3-a5b4-fa7013576a88" providerId="ADAL" clId="{A273B740-BFDD-4EA9-A43F-9869F50C3DDC}" dt="2023-03-06T06:02:25.155" v="4" actId="20577"/>
          <ac:spMkLst>
            <pc:docMk/>
            <pc:sldMk cId="2312700950" sldId="257"/>
            <ac:spMk id="24" creationId="{5B1EAF2C-8A79-9458-5301-40E912FBF2B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213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110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123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665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4295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606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6203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911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499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7117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0794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91552-5D30-4B09-9606-99347C9DE5E7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F7DD2-AB46-45D9-9912-518D759C8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7569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2A7A4D-22CA-1B2A-B6A6-AA877536BD52}"/>
              </a:ext>
            </a:extLst>
          </p:cNvPr>
          <p:cNvSpPr txBox="1"/>
          <p:nvPr/>
        </p:nvSpPr>
        <p:spPr>
          <a:xfrm>
            <a:off x="477776" y="1204755"/>
            <a:ext cx="5497140" cy="12958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 for</a:t>
            </a:r>
            <a:endParaRPr lang="en-US" sz="1800" b="1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rtial Miscibility and Concentration Distribution of Two-phase Blends of Crosslinked NBR and PVC</a:t>
            </a:r>
            <a:r>
              <a:rPr lang="ja-JP" altLang="en-US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endParaRPr lang="en-US" sz="1400" b="1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664D567-9733-C2B0-4A3D-582C37AA3698}"/>
              </a:ext>
            </a:extLst>
          </p:cNvPr>
          <p:cNvSpPr txBox="1"/>
          <p:nvPr/>
        </p:nvSpPr>
        <p:spPr>
          <a:xfrm>
            <a:off x="477776" y="4273498"/>
            <a:ext cx="5785237" cy="22159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Yuka Komori </a:t>
            </a:r>
            <a:r>
              <a:rPr lang="en-US" altLang="ja-JP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, 2,*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Aoi Taniguchi </a:t>
            </a:r>
            <a:r>
              <a:rPr lang="en-US" altLang="ja-JP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Haruhisa Shibata </a:t>
            </a:r>
            <a:r>
              <a:rPr lang="en-US" altLang="ja-JP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Shinya Goto </a:t>
            </a:r>
            <a:r>
              <a:rPr lang="en-US" altLang="ja-JP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Hiromu Saito </a:t>
            </a:r>
            <a:r>
              <a:rPr lang="en-US" altLang="ja-JP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endParaRPr lang="en-US" sz="1400" kern="100" baseline="300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endParaRPr lang="en-US" sz="1800" kern="100" baseline="300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sz="180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aterials Engineering R&amp;D Division, DENSO CORPORATION,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riya-shi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ichi 448-8661, Japan</a:t>
            </a:r>
          </a:p>
          <a:p>
            <a:pPr algn="just"/>
            <a:r>
              <a:rPr lang="en-US" sz="180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Organic and Polymer Materials Chemistry, Tokyo University of Agriculture and Technology, Koganei-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hi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Tokyo 184-8588, Japan</a:t>
            </a:r>
            <a:endParaRPr lang="en-US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3390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B1EAF2C-8A79-9458-5301-40E912FBF2BA}"/>
              </a:ext>
            </a:extLst>
          </p:cNvPr>
          <p:cNvSpPr txBox="1"/>
          <p:nvPr/>
        </p:nvSpPr>
        <p:spPr>
          <a:xfrm>
            <a:off x="388307" y="6950294"/>
            <a:ext cx="5749446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S1. Optical micrographs for phase structure of NBR/PVC blends at various compositions obtained by annealing the solvent-cast</a:t>
            </a:r>
            <a:r>
              <a:rPr lang="ja-JP" altLang="en-US" dirty="0"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lms at 140 </a:t>
            </a:r>
            <a:r>
              <a:rPr lang="en-US" altLang="ja-JP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sym typeface="Symbol" panose="05050102010706020507" pitchFamily="18" charset="2"/>
              </a:rPr>
              <a:t>C </a:t>
            </a:r>
            <a:r>
              <a:rPr lang="en-US" altLang="ja-JP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or 1h: (a) 95/5 NBR/PVC; (b) 80/20 NBR/PVC; (c) 60/40 NBR/PVC; (d) 20/80 NBR/PVC.</a:t>
            </a:r>
            <a:endParaRPr lang="ja-JP" altLang="ja-JP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0" name="図 29" descr="QR コード&#10;&#10;低い精度で自動的に生成された説明">
            <a:extLst>
              <a:ext uri="{FF2B5EF4-FFF2-40B4-BE49-F238E27FC236}">
                <a16:creationId xmlns:a16="http://schemas.microsoft.com/office/drawing/2014/main" id="{10EF49D6-2CDF-6E17-5DED-963CF90808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618" y="1172455"/>
            <a:ext cx="2560320" cy="2601884"/>
          </a:xfrm>
          <a:prstGeom prst="rect">
            <a:avLst/>
          </a:prstGeom>
        </p:spPr>
      </p:pic>
      <p:pic>
        <p:nvPicPr>
          <p:cNvPr id="32" name="図 31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0FB56EF2-358E-7BBD-7207-6F94EFD1B17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887" y="1166514"/>
            <a:ext cx="2563091" cy="2601884"/>
          </a:xfrm>
          <a:prstGeom prst="rect">
            <a:avLst/>
          </a:prstGeom>
        </p:spPr>
      </p:pic>
      <p:pic>
        <p:nvPicPr>
          <p:cNvPr id="34" name="図 33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3C8FA617-240F-A99B-7068-30DAB8597D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618" y="3901991"/>
            <a:ext cx="2560320" cy="2593571"/>
          </a:xfrm>
          <a:prstGeom prst="rect">
            <a:avLst/>
          </a:prstGeom>
        </p:spPr>
      </p:pic>
      <p:pic>
        <p:nvPicPr>
          <p:cNvPr id="36" name="図 35" descr="文字の書かれた紙&#10;&#10;自動的に生成された説明">
            <a:extLst>
              <a:ext uri="{FF2B5EF4-FFF2-40B4-BE49-F238E27FC236}">
                <a16:creationId xmlns:a16="http://schemas.microsoft.com/office/drawing/2014/main" id="{D67A7046-FF57-4E9E-FB92-BF444C078ED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0116" y="3896449"/>
            <a:ext cx="2565862" cy="2599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2700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DD5C823-45C1-B405-4038-A0B86E21696C}"/>
              </a:ext>
            </a:extLst>
          </p:cNvPr>
          <p:cNvSpPr txBox="1"/>
          <p:nvPr/>
        </p:nvSpPr>
        <p:spPr>
          <a:xfrm>
            <a:off x="554277" y="6877418"/>
            <a:ext cx="574944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S2. DSC thermograms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a heating rate of 10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/min for the melt-mixed NBR/PVC blends at various compositions and the neat component polymers. </a:t>
            </a:r>
            <a:endParaRPr lang="ja-JP" altLang="ja-JP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7" name="図 36" descr="グラフ, 折れ線グラフ&#10;&#10;自動的に生成された説明">
            <a:extLst>
              <a:ext uri="{FF2B5EF4-FFF2-40B4-BE49-F238E27FC236}">
                <a16:creationId xmlns:a16="http://schemas.microsoft.com/office/drawing/2014/main" id="{BC3DD355-D3BB-0D28-C8E6-C3147741FC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578" y="2119319"/>
            <a:ext cx="5710844" cy="35689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5984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32D8B21B-955C-4FCD-827F-CFFB49D5CE5C}" vid="{6CFFB422-D755-4B06-964F-9C055C518433}"/>
    </a:ext>
  </a:extLst>
</a:theme>
</file>

<file path=docMetadata/LabelInfo.xml><?xml version="1.0" encoding="utf-8"?>
<clbl:labelList xmlns:clbl="http://schemas.microsoft.com/office/2020/mipLabelMetadata">
  <clbl:label id="{69405920-b673-4f7c-8845-e124e9d08af2}" enabled="0" method="" siteId="{69405920-b673-4f7c-8845-e124e9d08af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65</TotalTime>
  <Words>165</Words>
  <Application>Microsoft Office PowerPoint</Application>
  <PresentationFormat>画面に合わせる (4:3)</PresentationFormat>
  <Paragraphs>8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游明朝</vt:lpstr>
      <vt:lpstr>Arial</vt:lpstr>
      <vt:lpstr>Calibri</vt:lpstr>
      <vt:lpstr>Calibri Light</vt:lpstr>
      <vt:lpstr>Palatino Linotype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S</dc:creator>
  <cp:lastModifiedBy>Yuka Komori (小森 裕香)</cp:lastModifiedBy>
  <cp:revision>3</cp:revision>
  <dcterms:created xsi:type="dcterms:W3CDTF">2023-03-01T06:40:16Z</dcterms:created>
  <dcterms:modified xsi:type="dcterms:W3CDTF">2023-03-09T10:47:41Z</dcterms:modified>
</cp:coreProperties>
</file>